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96" r:id="rId1"/>
  </p:sldMasterIdLst>
  <p:sldIdLst>
    <p:sldId id="261" r:id="rId2"/>
  </p:sldIdLst>
  <p:sldSz cx="6858000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86" d="100"/>
          <a:sy n="86" d="100"/>
        </p:scale>
        <p:origin x="127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346836"/>
            <a:ext cx="5829300" cy="286512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322446"/>
            <a:ext cx="5143500" cy="1986914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00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240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38150"/>
            <a:ext cx="1478756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38150"/>
            <a:ext cx="4350544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04397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630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051688"/>
            <a:ext cx="5915025" cy="3423284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507358"/>
            <a:ext cx="5915025" cy="180022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6100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190750"/>
            <a:ext cx="29146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190750"/>
            <a:ext cx="29146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395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38152"/>
            <a:ext cx="5915025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017396"/>
            <a:ext cx="2901255" cy="98869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006090"/>
            <a:ext cx="2901255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017396"/>
            <a:ext cx="2915543" cy="98869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006090"/>
            <a:ext cx="2915543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3641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21033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770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48640"/>
            <a:ext cx="2211884" cy="19202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184912"/>
            <a:ext cx="3471863" cy="584835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68880"/>
            <a:ext cx="2211884" cy="457390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5527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48640"/>
            <a:ext cx="2211884" cy="19202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184912"/>
            <a:ext cx="3471863" cy="584835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68880"/>
            <a:ext cx="2211884" cy="457390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47826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38152"/>
            <a:ext cx="5915025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190750"/>
            <a:ext cx="5915025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7627622"/>
            <a:ext cx="154305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7627622"/>
            <a:ext cx="2314575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7627622"/>
            <a:ext cx="154305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4890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E288314B-6FE7-6780-A7C4-D104DF181D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pic>
        <p:nvPicPr>
          <p:cNvPr id="1025" name="Picture 1" descr="Obrázok, na ktorom je text, snímka obrazovky, rad, diagram&#10;&#10;Automaticky generovaný popis">
            <a:extLst>
              <a:ext uri="{FF2B5EF4-FFF2-40B4-BE49-F238E27FC236}">
                <a16:creationId xmlns:a16="http://schemas.microsoft.com/office/drawing/2014/main" id="{27F814A3-4173-8541-AD34-B7F3DD2B572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450" y="376640"/>
            <a:ext cx="6439788" cy="21755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 descr="Obrázok, na ktorom je kruh, diagram, snímka obrazovky&#10;&#10;Automaticky generovaný popis">
            <a:extLst>
              <a:ext uri="{FF2B5EF4-FFF2-40B4-BE49-F238E27FC236}">
                <a16:creationId xmlns:a16="http://schemas.microsoft.com/office/drawing/2014/main" id="{5BFE390E-31E0-5F9D-7B7B-9A1C88EDFEF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785"/>
          <a:stretch/>
        </p:blipFill>
        <p:spPr bwMode="auto">
          <a:xfrm>
            <a:off x="297952" y="2568575"/>
            <a:ext cx="5650786" cy="3638978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28813854-EE4A-87D1-F4E4-7722C548F9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1450" y="6415333"/>
            <a:ext cx="6515100" cy="13142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82296" tIns="41148" rIns="82296" bIns="41148" numCol="1" anchor="ctr" anchorCtr="0" compatLnSpc="1">
            <a:prstTxWarp prst="textNoShape">
              <a:avLst/>
            </a:prstTxWarp>
            <a:spAutoFit/>
          </a:bodyPr>
          <a:lstStyle/>
          <a:p>
            <a:pPr algn="just" defTabSz="82296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600" b="1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. Figure </a:t>
            </a:r>
            <a:r>
              <a:rPr lang="sk-SK" altLang="en-US" sz="1600" b="1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altLang="en-US" sz="1600" b="1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en-US" sz="16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en-US" sz="16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sk-SK" altLang="en-US" sz="16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itial</a:t>
            </a:r>
            <a:r>
              <a:rPr lang="en-GB" altLang="en-US" sz="16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roteomic analysis of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PC3 cells (10</a:t>
            </a:r>
            <a:r>
              <a:rPr lang="en-US" sz="1600" i="1" baseline="30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6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) incubated for 2h with 100 µg</a:t>
            </a:r>
            <a:r>
              <a:rPr lang="en-US" sz="16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/mL of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</a:t>
            </a:r>
            <a:r>
              <a:rPr lang="en-US" sz="1600" i="1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mAb</a:t>
            </a:r>
            <a:r>
              <a:rPr lang="en-US" sz="1600" i="1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2B8. </a:t>
            </a:r>
            <a:r>
              <a:rPr lang="sk-SK" altLang="en-US" sz="1600" i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sk-SK" altLang="en-US" sz="16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r>
              <a:rPr lang="en-GB" altLang="en-US" sz="16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incipal Component Analysis (PCA) illustrating the clustering of PC3 cell samples based on proteomic profiles;</a:t>
            </a:r>
            <a:r>
              <a:rPr lang="sk-SK" altLang="en-US" sz="16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B)</a:t>
            </a:r>
            <a:r>
              <a:rPr lang="en-GB" altLang="en-US" sz="16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enn diagram displaying the number of proteins uniquely identified in PC3 treated cells, the untreated control, and the number of shared proteins.</a:t>
            </a:r>
            <a:endParaRPr lang="en-US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BlokTextu 1">
            <a:extLst>
              <a:ext uri="{FF2B5EF4-FFF2-40B4-BE49-F238E27FC236}">
                <a16:creationId xmlns:a16="http://schemas.microsoft.com/office/drawing/2014/main" id="{A56CC8A1-A7A2-BD67-D249-2089061136F9}"/>
              </a:ext>
            </a:extLst>
          </p:cNvPr>
          <p:cNvSpPr txBox="1"/>
          <p:nvPr/>
        </p:nvSpPr>
        <p:spPr>
          <a:xfrm>
            <a:off x="200197" y="308664"/>
            <a:ext cx="4424353" cy="276999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                                                                         </a:t>
            </a:r>
          </a:p>
        </p:txBody>
      </p:sp>
      <p:sp>
        <p:nvSpPr>
          <p:cNvPr id="9" name="BlokTextu 1">
            <a:extLst>
              <a:ext uri="{FF2B5EF4-FFF2-40B4-BE49-F238E27FC236}">
                <a16:creationId xmlns:a16="http://schemas.microsoft.com/office/drawing/2014/main" id="{1C30C102-5B49-3C47-3CFB-45645571B59A}"/>
              </a:ext>
            </a:extLst>
          </p:cNvPr>
          <p:cNvSpPr txBox="1"/>
          <p:nvPr/>
        </p:nvSpPr>
        <p:spPr>
          <a:xfrm>
            <a:off x="297951" y="2546397"/>
            <a:ext cx="482885" cy="2769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sk-SK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</a:t>
            </a:r>
          </a:p>
        </p:txBody>
      </p:sp>
      <p:sp>
        <p:nvSpPr>
          <p:cNvPr id="10" name="BlokTextu 1">
            <a:extLst>
              <a:ext uri="{FF2B5EF4-FFF2-40B4-BE49-F238E27FC236}">
                <a16:creationId xmlns:a16="http://schemas.microsoft.com/office/drawing/2014/main" id="{6DB24EDF-0252-8350-A1A7-32C5D50854E6}"/>
              </a:ext>
            </a:extLst>
          </p:cNvPr>
          <p:cNvSpPr txBox="1"/>
          <p:nvPr/>
        </p:nvSpPr>
        <p:spPr>
          <a:xfrm>
            <a:off x="313693" y="3036553"/>
            <a:ext cx="713724" cy="215444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sk-SK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3</a:t>
            </a:r>
            <a:r>
              <a:rPr lang="sk-SK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k-SK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sk-SK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</a:t>
            </a:r>
          </a:p>
        </p:txBody>
      </p:sp>
      <p:sp>
        <p:nvSpPr>
          <p:cNvPr id="11" name="BlokTextu 1">
            <a:extLst>
              <a:ext uri="{FF2B5EF4-FFF2-40B4-BE49-F238E27FC236}">
                <a16:creationId xmlns:a16="http://schemas.microsoft.com/office/drawing/2014/main" id="{805C7ADA-7A71-9D2E-1C4D-1B1CE4565045}"/>
              </a:ext>
            </a:extLst>
          </p:cNvPr>
          <p:cNvSpPr txBox="1"/>
          <p:nvPr/>
        </p:nvSpPr>
        <p:spPr>
          <a:xfrm>
            <a:off x="5474082" y="2928833"/>
            <a:ext cx="1137156" cy="64633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sk-SK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3 </a:t>
            </a:r>
            <a:r>
              <a:rPr lang="sk-SK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sk-SK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sk-SK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ated</a:t>
            </a:r>
            <a:r>
              <a:rPr lang="sk-SK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k-SK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sk-SK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k-SK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sk-SK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B8</a:t>
            </a:r>
            <a:r>
              <a:rPr lang="sk-SK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            </a:t>
            </a:r>
          </a:p>
        </p:txBody>
      </p:sp>
    </p:spTree>
    <p:extLst>
      <p:ext uri="{BB962C8B-B14F-4D97-AF65-F5344CB8AC3E}">
        <p14:creationId xmlns:p14="http://schemas.microsoft.com/office/powerpoint/2010/main" val="16549367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265</TotalTime>
  <Words>86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do Skultety</dc:creator>
  <cp:lastModifiedBy>Ludovit Skultety</cp:lastModifiedBy>
  <cp:revision>20</cp:revision>
  <dcterms:created xsi:type="dcterms:W3CDTF">2023-04-23T08:26:50Z</dcterms:created>
  <dcterms:modified xsi:type="dcterms:W3CDTF">2024-12-04T14:58:09Z</dcterms:modified>
</cp:coreProperties>
</file>